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30" d="100"/>
          <a:sy n="130" d="100"/>
        </p:scale>
        <p:origin x="588" y="-411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898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3054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889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0980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043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2816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3147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30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555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1121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013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3EAE9-471E-48AC-83DE-8606DEF1C8FB}" type="datetimeFigureOut">
              <a:rPr lang="en-GB" smtClean="0"/>
              <a:t>28/0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652E49-4A89-4C17-AE58-2489A07D149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391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2083" y="555165"/>
            <a:ext cx="4831258" cy="806404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45792" y="276546"/>
            <a:ext cx="427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364736" y="27654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33086" y="1304544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lif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86837" y="3315839"/>
            <a:ext cx="9605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N 1 day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1421" y="5327134"/>
            <a:ext cx="1063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N 2 days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1421" y="7338428"/>
            <a:ext cx="106311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N 6 days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71421" y="8629955"/>
            <a:ext cx="6236643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n-GB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of proliferating and nitrogen-starved G0 cells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ild type an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rain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were grown to mid log phase in EMM medium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rolif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and then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spend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 EMM-N medium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incubated at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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 (-N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r the indicated times. Aliquots of cell culture were taken stained with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tox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green and DNA content (C) analysed by flow cytometry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Like wild type cells, the majority of nitrogen starved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hip1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cells arrest in G0 with a 1C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DNA content which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s maintained for at least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6 day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804900" y="4319516"/>
            <a:ext cx="617047" cy="230832"/>
            <a:chOff x="1804900" y="4307927"/>
            <a:chExt cx="617047" cy="230832"/>
          </a:xfrm>
        </p:grpSpPr>
        <p:sp>
          <p:nvSpPr>
            <p:cNvPr id="2" name="TextBox 1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828518" y="6344740"/>
            <a:ext cx="617047" cy="230832"/>
            <a:chOff x="1804900" y="4307927"/>
            <a:chExt cx="617047" cy="230832"/>
          </a:xfrm>
        </p:grpSpPr>
        <p:sp>
          <p:nvSpPr>
            <p:cNvPr id="14" name="TextBox 13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1852136" y="8306564"/>
            <a:ext cx="617047" cy="230832"/>
            <a:chOff x="1804900" y="4307927"/>
            <a:chExt cx="617047" cy="230832"/>
          </a:xfrm>
        </p:grpSpPr>
        <p:sp>
          <p:nvSpPr>
            <p:cNvPr id="17" name="TextBox 16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4222298" y="8306564"/>
            <a:ext cx="617047" cy="230832"/>
            <a:chOff x="1804900" y="4307927"/>
            <a:chExt cx="617047" cy="230832"/>
          </a:xfrm>
        </p:grpSpPr>
        <p:sp>
          <p:nvSpPr>
            <p:cNvPr id="20" name="TextBox 19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4222298" y="6344740"/>
            <a:ext cx="617047" cy="230832"/>
            <a:chOff x="1804900" y="4307927"/>
            <a:chExt cx="617047" cy="230832"/>
          </a:xfrm>
        </p:grpSpPr>
        <p:sp>
          <p:nvSpPr>
            <p:cNvPr id="23" name="TextBox 22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222298" y="4319516"/>
            <a:ext cx="617047" cy="230832"/>
            <a:chOff x="1804900" y="4307927"/>
            <a:chExt cx="617047" cy="230832"/>
          </a:xfrm>
        </p:grpSpPr>
        <p:sp>
          <p:nvSpPr>
            <p:cNvPr id="26" name="TextBox 25"/>
            <p:cNvSpPr txBox="1"/>
            <p:nvPr/>
          </p:nvSpPr>
          <p:spPr>
            <a:xfrm>
              <a:off x="1804900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89805" y="4307927"/>
              <a:ext cx="33214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C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2066186" y="2283565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483584" y="2283565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C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4273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ff86b73-d2ed-45d1-9e31-5b4a0d263f49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9D959B2D8FA5C4980890EF71530081A" ma:contentTypeVersion="14" ma:contentTypeDescription="Create a new document." ma:contentTypeScope="" ma:versionID="32fa3c235032fb6ef437c97435266abb">
  <xsd:schema xmlns:xsd="http://www.w3.org/2001/XMLSchema" xmlns:xs="http://www.w3.org/2001/XMLSchema" xmlns:p="http://schemas.microsoft.com/office/2006/metadata/properties" xmlns:ns3="1ff86b73-d2ed-45d1-9e31-5b4a0d263f49" xmlns:ns4="917767b3-d7cc-4621-8ad9-27e46fe3c43e" targetNamespace="http://schemas.microsoft.com/office/2006/metadata/properties" ma:root="true" ma:fieldsID="b46a7b92e6b6a21088fcbb1ddad5d57c" ns3:_="" ns4:_="">
    <xsd:import namespace="1ff86b73-d2ed-45d1-9e31-5b4a0d263f49"/>
    <xsd:import namespace="917767b3-d7cc-4621-8ad9-27e46fe3c43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ff86b73-d2ed-45d1-9e31-5b4a0d263f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17767b3-d7cc-4621-8ad9-27e46fe3c43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8D1C002-DAF1-4BFC-A460-CDAEB9BCA7F8}">
  <ds:schemaRefs>
    <ds:schemaRef ds:uri="http://purl.org/dc/elements/1.1/"/>
    <ds:schemaRef ds:uri="http://schemas.microsoft.com/office/2006/metadata/properties"/>
    <ds:schemaRef ds:uri="1ff86b73-d2ed-45d1-9e31-5b4a0d263f49"/>
    <ds:schemaRef ds:uri="http://purl.org/dc/terms/"/>
    <ds:schemaRef ds:uri="http://schemas.openxmlformats.org/package/2006/metadata/core-properties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0C440FF5-FE34-443D-A10F-215C0600BC0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09219B3-125F-44F6-88EA-393EA021F9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ff86b73-d2ed-45d1-9e31-5b4a0d263f49"/>
    <ds:schemaRef ds:uri="917767b3-d7cc-4621-8ad9-27e46fe3c43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132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>Newcastl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Whitehall</dc:creator>
  <cp:lastModifiedBy>Simon_Admin</cp:lastModifiedBy>
  <cp:revision>5</cp:revision>
  <dcterms:created xsi:type="dcterms:W3CDTF">2019-03-22T19:08:00Z</dcterms:created>
  <dcterms:modified xsi:type="dcterms:W3CDTF">2023-06-28T14:24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9D959B2D8FA5C4980890EF71530081A</vt:lpwstr>
  </property>
</Properties>
</file>